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61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4E64B3-C054-4494-8420-CE18C4C596E0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765B73-CB22-47C3-B839-3F86DEEED91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82692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931C-4BD9-4A08-A39B-C68E41D9394C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69BA-9A0F-4ED6-8772-E0B3222D87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6112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931C-4BD9-4A08-A39B-C68E41D9394C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69BA-9A0F-4ED6-8772-E0B3222D87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51735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931C-4BD9-4A08-A39B-C68E41D9394C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69BA-9A0F-4ED6-8772-E0B3222D87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8442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931C-4BD9-4A08-A39B-C68E41D9394C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69BA-9A0F-4ED6-8772-E0B3222D87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2845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931C-4BD9-4A08-A39B-C68E41D9394C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69BA-9A0F-4ED6-8772-E0B3222D87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6979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931C-4BD9-4A08-A39B-C68E41D9394C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69BA-9A0F-4ED6-8772-E0B3222D87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6346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931C-4BD9-4A08-A39B-C68E41D9394C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69BA-9A0F-4ED6-8772-E0B3222D87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5107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931C-4BD9-4A08-A39B-C68E41D9394C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69BA-9A0F-4ED6-8772-E0B3222D87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0372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931C-4BD9-4A08-A39B-C68E41D9394C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69BA-9A0F-4ED6-8772-E0B3222D87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4888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931C-4BD9-4A08-A39B-C68E41D9394C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69BA-9A0F-4ED6-8772-E0B3222D87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3883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7931C-4BD9-4A08-A39B-C68E41D9394C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069BA-9A0F-4ED6-8772-E0B3222D87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35952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B7931C-4BD9-4A08-A39B-C68E41D9394C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7069BA-9A0F-4ED6-8772-E0B3222D87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7512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3943530"/>
              </p:ext>
            </p:extLst>
          </p:nvPr>
        </p:nvGraphicFramePr>
        <p:xfrm>
          <a:off x="665249" y="1108465"/>
          <a:ext cx="10515369" cy="402336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801158">
                  <a:extLst>
                    <a:ext uri="{9D8B030D-6E8A-4147-A177-3AD203B41FA5}">
                      <a16:colId xmlns:a16="http://schemas.microsoft.com/office/drawing/2014/main" val="3631791561"/>
                    </a:ext>
                  </a:extLst>
                </a:gridCol>
                <a:gridCol w="897775">
                  <a:extLst>
                    <a:ext uri="{9D8B030D-6E8A-4147-A177-3AD203B41FA5}">
                      <a16:colId xmlns:a16="http://schemas.microsoft.com/office/drawing/2014/main" val="2802362284"/>
                    </a:ext>
                  </a:extLst>
                </a:gridCol>
                <a:gridCol w="2635134">
                  <a:extLst>
                    <a:ext uri="{9D8B030D-6E8A-4147-A177-3AD203B41FA5}">
                      <a16:colId xmlns:a16="http://schemas.microsoft.com/office/drawing/2014/main" val="367609754"/>
                    </a:ext>
                  </a:extLst>
                </a:gridCol>
                <a:gridCol w="3350029">
                  <a:extLst>
                    <a:ext uri="{9D8B030D-6E8A-4147-A177-3AD203B41FA5}">
                      <a16:colId xmlns:a16="http://schemas.microsoft.com/office/drawing/2014/main" val="15766010"/>
                    </a:ext>
                  </a:extLst>
                </a:gridCol>
                <a:gridCol w="831273">
                  <a:extLst>
                    <a:ext uri="{9D8B030D-6E8A-4147-A177-3AD203B41FA5}">
                      <a16:colId xmlns:a16="http://schemas.microsoft.com/office/drawing/2014/main" val="202332895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Total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MRI</a:t>
                      </a:r>
                      <a:endParaRPr lang="ko-KR" sz="1200" kern="100">
                        <a:effectLst/>
                      </a:endParaRPr>
                    </a:p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(n=55)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No MRI</a:t>
                      </a:r>
                      <a:endParaRPr lang="ko-KR" sz="1200" kern="100">
                        <a:effectLst/>
                      </a:endParaRPr>
                    </a:p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(n=97)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p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60752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Age, y 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152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68.2</a:t>
                      </a:r>
                      <a:r>
                        <a:rPr lang="en-US" sz="1200" kern="50">
                          <a:effectLst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kern="50">
                          <a:effectLst/>
                        </a:rPr>
                        <a:t>4.5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73.1</a:t>
                      </a:r>
                      <a:r>
                        <a:rPr lang="en-US" sz="1200" kern="50">
                          <a:effectLst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kern="50">
                          <a:effectLst/>
                        </a:rPr>
                        <a:t>3.9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&lt;0.001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293576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Education, y 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152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11.1</a:t>
                      </a:r>
                      <a:r>
                        <a:rPr lang="en-US" sz="1200" kern="50">
                          <a:effectLst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kern="50">
                          <a:effectLst/>
                        </a:rPr>
                        <a:t>4.0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9.3</a:t>
                      </a:r>
                      <a:r>
                        <a:rPr lang="en-US" sz="1200" kern="50">
                          <a:effectLst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kern="50">
                          <a:effectLst/>
                        </a:rPr>
                        <a:t>5.1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0.015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9275781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Female, n (%) 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152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38 (69.1)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74 (76.3)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0.344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531797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APOE </a:t>
                      </a:r>
                      <a:r>
                        <a:rPr lang="en-US" sz="1200" kern="50">
                          <a:effectLst/>
                          <a:sym typeface="Symbol" panose="05050102010706020507" pitchFamily="18" charset="2"/>
                        </a:rPr>
                        <a:t></a:t>
                      </a:r>
                      <a:r>
                        <a:rPr lang="en-US" sz="1200" kern="50">
                          <a:effectLst/>
                        </a:rPr>
                        <a:t>4 carriers, n (%) 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151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8 (14.8)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18 (18.6)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 dirty="0">
                          <a:effectLst/>
                        </a:rPr>
                        <a:t>0.656</a:t>
                      </a:r>
                      <a:endParaRPr lang="ko-KR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27261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RBANS at baseline 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152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108.6</a:t>
                      </a:r>
                      <a:r>
                        <a:rPr lang="en-US" sz="1200" kern="50">
                          <a:effectLst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kern="50">
                          <a:effectLst/>
                        </a:rPr>
                        <a:t>17.3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95.8</a:t>
                      </a:r>
                      <a:r>
                        <a:rPr lang="en-US" sz="1200" kern="50">
                          <a:effectLst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kern="50">
                          <a:effectLst/>
                        </a:rPr>
                        <a:t>17.9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&lt;0.001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544711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Group (control/FMI/HMI), n (%) 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152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16 (29.1)/20 (36.4)/19 (34.5)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34 (35.1)/31 (32.0)/32 (33.0)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0.738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483454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Adherence, % 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102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96.5</a:t>
                      </a:r>
                      <a:r>
                        <a:rPr lang="en-US" sz="1200" kern="50">
                          <a:effectLst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kern="50">
                          <a:effectLst/>
                        </a:rPr>
                        <a:t>4.6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>
                          <a:effectLst/>
                        </a:rPr>
                        <a:t>95.1</a:t>
                      </a:r>
                      <a:r>
                        <a:rPr lang="en-US" sz="1200" kern="50">
                          <a:effectLst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kern="50">
                          <a:effectLst/>
                        </a:rPr>
                        <a:t>10.1</a:t>
                      </a:r>
                      <a:endParaRPr lang="ko-KR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50" dirty="0">
                          <a:effectLst/>
                        </a:rPr>
                        <a:t>0.426</a:t>
                      </a:r>
                      <a:endParaRPr lang="ko-KR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437985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297412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120</Words>
  <Application>Microsoft Office PowerPoint</Application>
  <PresentationFormat>와이드스크린</PresentationFormat>
  <Paragraphs>4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Symbo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문소영</dc:creator>
  <cp:lastModifiedBy>문소영</cp:lastModifiedBy>
  <cp:revision>6</cp:revision>
  <dcterms:created xsi:type="dcterms:W3CDTF">2021-01-14T05:32:17Z</dcterms:created>
  <dcterms:modified xsi:type="dcterms:W3CDTF">2022-02-14T03:16:21Z</dcterms:modified>
</cp:coreProperties>
</file>